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43"/>
    <p:restoredTop sz="94631"/>
  </p:normalViewPr>
  <p:slideViewPr>
    <p:cSldViewPr snapToGrid="0" snapToObjects="1">
      <p:cViewPr varScale="1">
        <p:scale>
          <a:sx n="70" d="100"/>
          <a:sy n="70" d="100"/>
        </p:scale>
        <p:origin x="57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92BDA30-2882-0E49-93E4-ABBCD8F738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CE8E0A60-FF1F-5B4B-AF86-124B2855A3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F9C8794-315B-4647-BE4D-3E641913C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6A77D22-8B02-D447-AC37-782FF55FF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D91A199-E71D-BC42-9400-387BE9557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213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6696978-D915-304A-A3B3-6695E609CE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1D75FA84-264A-8042-BDA4-31248E676E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7D517A6-CA58-644B-9BFE-640B4C6B0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CE5E530-5626-AD41-ACD2-B931D2F1D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0108F12-61A4-6D4C-834D-17E54CD43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24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546467B0-D575-8C4A-89DC-692521F1A1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7A7C8DB6-678A-E14E-9801-5DE3664CB3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B7708BB-0C2A-094A-9905-1B7D8D1C3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4AEC2EE-7030-CA48-828A-344EC2451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6565E57-ACB2-EB47-BCD3-597D29486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117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960AA46-9F6D-3149-81E4-AD2D86A911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82B9AAD-4C5B-F648-9C0D-10A56E48B5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3AB5570-C807-4B45-A1ED-2E3755B45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BE4121AD-CD03-4945-A99E-D1EEA6918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3F3669B-068A-5148-A83F-DB7843710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899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593EEFF-A703-0A4F-89B1-C956CB950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D6748C54-14BA-554E-98B0-3B0B11D78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93D917C-2F3F-7E4A-B126-5EEA1D25F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62E8D08-77E3-1D49-A2A7-B13C39CCC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5398CD9-1BBF-4C4B-A789-5976241A7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668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241D22F-0D85-0844-97FB-A85061F61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8344BB92-05D4-0A43-B393-E4AD559194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AC4AF50-1B61-1A40-91A5-BA9EABE282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EF19033-1268-4E41-A682-9890F90E6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F7F4B5F-10C4-1943-86A9-118264944B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A113EE3E-3AB3-8A40-AF30-EE420F9EA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15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36F5FF6-81C6-9F49-B603-5DE77119AD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C7BE01E-D18D-D04D-AD20-F03B1100E9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D08FAF71-1AA7-294D-BC16-80BFDEBFC0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6814494E-F2F4-0A4E-A3C1-9C7EFF3518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CB518646-ACE6-DA40-B05A-6C65884AC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782D69BD-E2B3-3A45-BB72-BF6701DCB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144B7034-6AA4-EE4A-9B6C-E17C516E3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A08D8E54-067A-5A49-9EC4-28D0FBA6C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1006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D477077-96FF-504A-A4E7-D294C5BDAB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7D18EDC2-63CA-E04C-84AE-F698414C0C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2950DCE1-5C18-A24F-98A5-4FD7F703E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7EB8850A-FCD5-B04E-B898-45519FD39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437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E267CE54-81DF-A844-9476-D37063914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669FFD4E-1E46-3944-BE6A-B1D5553BF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9EDFDF78-696B-834A-9C86-2BEB53DE9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91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1DDA239-2A55-6743-8B29-28F77505CB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181B00ED-B27F-3E47-A7AB-0D76EF8339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356EE7FB-ED51-1747-BECB-22D2F63DF2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D239B29D-4CEA-6249-B36A-7AA06E00E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36086FB-2504-2340-9BF9-D3BFBCC2A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AF1306D3-96CD-7F45-9FAE-A5852E4D7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051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4F25711-D3B1-D441-BF53-2A7D11ED8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BC8C93D3-26BB-3743-ACBD-810544C156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903D92C7-3880-6E47-9680-9B76D7D02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028D0FB-AF88-A141-8F22-3434E790A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B4704289-CBC2-E34B-B15F-4F3155FF2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842A1224-2E54-1348-8BD0-8813369C0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171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8E887AB2-C369-C74E-BC8E-09E1C7FA9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F88D87BC-F439-424A-BE48-C5062C9B1A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33B9A49-F9B1-2146-A480-8C9DAB2AF1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C5905-C128-9D43-887C-EE1A3192FEF3}" type="datetimeFigureOut">
              <a:rPr kumimoji="1" lang="ja-JP" altLang="en-US" smtClean="0"/>
              <a:t>2019/10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1B4D1E9-8981-6041-9FA7-5879B71266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85DE61A-172E-C44A-8249-A4FD3D18C9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A750E-635C-D641-AA01-42E318F873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437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xmlns="" id="{A418F9A9-A2AB-DC46-A818-A3BCC1AEC8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7123388"/>
              </p:ext>
            </p:extLst>
          </p:nvPr>
        </p:nvGraphicFramePr>
        <p:xfrm>
          <a:off x="2231757" y="840019"/>
          <a:ext cx="7862808" cy="4876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10468">
                  <a:extLst>
                    <a:ext uri="{9D8B030D-6E8A-4147-A177-3AD203B41FA5}">
                      <a16:colId xmlns:a16="http://schemas.microsoft.com/office/drawing/2014/main" xmlns="" val="3545543508"/>
                    </a:ext>
                  </a:extLst>
                </a:gridCol>
                <a:gridCol w="1310468">
                  <a:extLst>
                    <a:ext uri="{9D8B030D-6E8A-4147-A177-3AD203B41FA5}">
                      <a16:colId xmlns:a16="http://schemas.microsoft.com/office/drawing/2014/main" xmlns="" val="1447955975"/>
                    </a:ext>
                  </a:extLst>
                </a:gridCol>
                <a:gridCol w="1310468">
                  <a:extLst>
                    <a:ext uri="{9D8B030D-6E8A-4147-A177-3AD203B41FA5}">
                      <a16:colId xmlns:a16="http://schemas.microsoft.com/office/drawing/2014/main" xmlns="" val="3822799714"/>
                    </a:ext>
                  </a:extLst>
                </a:gridCol>
                <a:gridCol w="1310468">
                  <a:extLst>
                    <a:ext uri="{9D8B030D-6E8A-4147-A177-3AD203B41FA5}">
                      <a16:colId xmlns:a16="http://schemas.microsoft.com/office/drawing/2014/main" xmlns="" val="1130125503"/>
                    </a:ext>
                  </a:extLst>
                </a:gridCol>
                <a:gridCol w="1310468">
                  <a:extLst>
                    <a:ext uri="{9D8B030D-6E8A-4147-A177-3AD203B41FA5}">
                      <a16:colId xmlns:a16="http://schemas.microsoft.com/office/drawing/2014/main" xmlns="" val="2270570516"/>
                    </a:ext>
                  </a:extLst>
                </a:gridCol>
                <a:gridCol w="1310468">
                  <a:extLst>
                    <a:ext uri="{9D8B030D-6E8A-4147-A177-3AD203B41FA5}">
                      <a16:colId xmlns:a16="http://schemas.microsoft.com/office/drawing/2014/main" xmlns="" val="3164976302"/>
                    </a:ext>
                  </a:extLst>
                </a:gridCol>
              </a:tblGrid>
              <a:tr h="370840">
                <a:tc gridSpan="6">
                  <a:txBody>
                    <a:bodyPr/>
                    <a:lstStyle/>
                    <a:p>
                      <a:pPr algn="l"/>
                      <a:r>
                        <a:rPr kumimoji="1" lang="en-US" altLang="ja-JP" sz="11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pplemental </a:t>
                      </a:r>
                      <a:r>
                        <a:rPr kumimoji="1" lang="en-US" altLang="ja-JP" sz="1100" b="1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ble 2</a:t>
                      </a:r>
                      <a:r>
                        <a:rPr lang="ja-JP" altLang="ja-JP" sz="11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altLang="ja-JP" sz="11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fluorescence intensity in the interstitial space at all time points</a:t>
                      </a:r>
                      <a:endParaRPr kumimoji="1" lang="ja-JP" altLang="en-US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69021169"/>
                  </a:ext>
                </a:extLst>
              </a:tr>
              <a:tr h="370840">
                <a:tc gridSpan="6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average fluorescence intensity of </a:t>
                      </a:r>
                      <a:r>
                        <a:rPr lang="en-US" altLang="ja-JP" sz="12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R-DEX40</a:t>
                      </a:r>
                      <a:endParaRPr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2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36078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260154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 (N=5)</a:t>
                      </a:r>
                      <a:endParaRPr kumimoji="1" lang="ja-JP" alt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2.80±13.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4.3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4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1.41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.6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9.89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9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3.78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1.1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1624454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 (N=5)</a:t>
                      </a:r>
                      <a:endParaRPr kumimoji="1" lang="ja-JP" alt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4.72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5.6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9.87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6.1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1.82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5.9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6.06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9.6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8.71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2.1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944565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 (N=5)</a:t>
                      </a:r>
                      <a:endParaRPr kumimoji="1" lang="ja-JP" alt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5.9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4.8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6.37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2.4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4.3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3.6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5.22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5.8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5.64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1.3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391839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 (N=5)</a:t>
                      </a:r>
                      <a:endParaRPr kumimoji="1" lang="ja-JP" altLang="en-US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4.7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6.9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6.43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4.7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8.24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3.2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2.08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5.6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0.08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1.2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8275934"/>
                  </a:ext>
                </a:extLst>
              </a:tr>
              <a:tr h="370840">
                <a:tc gridSpan="6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average fluorescence intensity of FITC-HES70</a:t>
                      </a:r>
                      <a:endParaRPr lang="ja-JP" alt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en-US" sz="1200" b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998695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min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8305523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C (N=5)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3.5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5.7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5.56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4.0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9.71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1.0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8.7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4.1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0.7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5.0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8670817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 (N=5)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5.02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2.7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02.0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1.4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2.6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5.0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14.27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9.5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0.17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4.7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989767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A (N=5)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5.73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3.1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7.8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1.8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6.1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6.4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0.43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9.4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4.69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5.1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5156230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 NS-V (N=5)</a:t>
                      </a:r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9.75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5.4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6.92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.9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7.70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7.5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0.57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2.7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68.49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8.9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523268402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914F6D0C-1D3B-924E-840B-CD45A9235B1B}"/>
              </a:ext>
            </a:extLst>
          </p:cNvPr>
          <p:cNvSpPr txBox="1"/>
          <p:nvPr/>
        </p:nvSpPr>
        <p:spPr>
          <a:xfrm>
            <a:off x="2231757" y="5897546"/>
            <a:ext cx="7966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data are expressed as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± SD</a:t>
            </a:r>
            <a:endParaRPr kumimoji="1" lang="ja-JP" altLang="en-US" sz="11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997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125</Words>
  <Application>Microsoft Office PowerPoint</Application>
  <PresentationFormat>ワイド画面</PresentationFormat>
  <Paragraphs>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鵜澤康二</dc:creator>
  <cp:lastModifiedBy>tyorozu</cp:lastModifiedBy>
  <cp:revision>10</cp:revision>
  <dcterms:created xsi:type="dcterms:W3CDTF">2019-07-05T02:10:54Z</dcterms:created>
  <dcterms:modified xsi:type="dcterms:W3CDTF">2019-10-29T14:19:54Z</dcterms:modified>
</cp:coreProperties>
</file>